
<file path=[Content_Types].xml><?xml version="1.0" encoding="utf-8"?>
<Types xmlns="http://schemas.openxmlformats.org/package/2006/content-types">
  <Default Extension="tmp" ContentType="image/png"/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759671-C5CA-4B78-8A56-DDA68F66674A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E297B6-C390-4D97-80AA-80E917A6EA4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657915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22D111-ED7F-40BE-AD60-90B5E8A8B2BA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987024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FE094-813F-4F89-867A-01754FE1CB66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86E15-2F01-4238-83C9-D3C93029ACA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15009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FE094-813F-4F89-867A-01754FE1CB66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86E15-2F01-4238-83C9-D3C93029ACA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57181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FE094-813F-4F89-867A-01754FE1CB66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86E15-2F01-4238-83C9-D3C93029ACA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4163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FE094-813F-4F89-867A-01754FE1CB66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86E15-2F01-4238-83C9-D3C93029ACA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44984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FE094-813F-4F89-867A-01754FE1CB66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86E15-2F01-4238-83C9-D3C93029ACA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1684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FE094-813F-4F89-867A-01754FE1CB66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86E15-2F01-4238-83C9-D3C93029ACA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20568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FE094-813F-4F89-867A-01754FE1CB66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86E15-2F01-4238-83C9-D3C93029ACA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73131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FE094-813F-4F89-867A-01754FE1CB66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86E15-2F01-4238-83C9-D3C93029ACA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12665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FE094-813F-4F89-867A-01754FE1CB66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86E15-2F01-4238-83C9-D3C93029ACA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19290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FE094-813F-4F89-867A-01754FE1CB66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86E15-2F01-4238-83C9-D3C93029ACA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51735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FE094-813F-4F89-867A-01754FE1CB66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86E15-2F01-4238-83C9-D3C93029ACA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53219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3FE094-813F-4F89-867A-01754FE1CB66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D86E15-2F01-4238-83C9-D3C93029ACA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12208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m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Screen Clippi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6219" y="260935"/>
            <a:ext cx="8215246" cy="443083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9244327" y="2226030"/>
            <a:ext cx="11320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accent2">
                    <a:lumMod val="75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S/M P6_B2 </a:t>
            </a:r>
            <a:r>
              <a:rPr lang="en-US" sz="1200" dirty="0" smtClean="0">
                <a:solidFill>
                  <a:schemeClr val="accent2">
                    <a:lumMod val="75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G5</a:t>
            </a:r>
            <a:endParaRPr lang="en-US" sz="1200" dirty="0">
              <a:solidFill>
                <a:schemeClr val="accent2">
                  <a:lumMod val="75000"/>
                </a:schemeClr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9244327" y="363149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Chinese </a:t>
            </a:r>
            <a:r>
              <a:rPr lang="en-US" sz="12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Spring</a:t>
            </a:r>
            <a:endParaRPr lang="en-AU" sz="12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244327" y="1059985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accent2">
                    <a:lumMod val="75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Spica</a:t>
            </a:r>
            <a:endParaRPr lang="en-AU" sz="1200" dirty="0">
              <a:solidFill>
                <a:schemeClr val="accent2">
                  <a:lumMod val="75000"/>
                </a:schemeClr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9244327" y="1587544"/>
            <a:ext cx="1140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accent2">
                    <a:lumMod val="75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S/M P2_H3 </a:t>
            </a:r>
            <a:r>
              <a:rPr lang="en-US" sz="1200" dirty="0" smtClean="0">
                <a:solidFill>
                  <a:schemeClr val="accent2">
                    <a:lumMod val="75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D5</a:t>
            </a:r>
            <a:endParaRPr lang="en-US" sz="1200" dirty="0">
              <a:solidFill>
                <a:schemeClr val="accent2">
                  <a:lumMod val="75000"/>
                </a:schemeClr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244327" y="4126012"/>
            <a:ext cx="701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Maringa</a:t>
            </a:r>
            <a:endParaRPr lang="en-US" sz="12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244327" y="3490149"/>
            <a:ext cx="10983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S/M </a:t>
            </a:r>
            <a:r>
              <a:rPr lang="en-US" sz="12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P4_E1 F3</a:t>
            </a:r>
            <a:endParaRPr lang="en-US" sz="12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9244327" y="2861893"/>
            <a:ext cx="1131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S/M P8_H1 </a:t>
            </a:r>
            <a:r>
              <a:rPr lang="en-US" sz="12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en-US" sz="12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201930" y="5202121"/>
            <a:ext cx="1161669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AU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AU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AU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isualization in </a:t>
            </a:r>
            <a:r>
              <a:rPr lang="en-AU" sz="1200" b="1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V</a:t>
            </a:r>
            <a:r>
              <a:rPr lang="en-AU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n-AU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ad </a:t>
            </a:r>
            <a:r>
              <a:rPr lang="en-AU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verage of the recombinants from the Spica x Maringa mapping population across the 23kb candidate region</a:t>
            </a:r>
            <a:r>
              <a:rPr lang="en-AU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AU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ads were aligned to the </a:t>
            </a:r>
            <a:r>
              <a:rPr lang="en-AU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 </a:t>
            </a:r>
            <a:r>
              <a:rPr lang="en-AU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WGSC</a:t>
            </a:r>
            <a:r>
              <a:rPr lang="en-AU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fSeq</a:t>
            </a:r>
            <a:r>
              <a:rPr lang="en-AU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1.0</a:t>
            </a:r>
            <a:r>
              <a:rPr lang="en-AU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AU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NPs are represented as </a:t>
            </a:r>
            <a:r>
              <a:rPr lang="en-AU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loured </a:t>
            </a:r>
            <a:r>
              <a:rPr lang="en-AU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rtical lines (red=T, green= A, blue=C, orange=G). The top </a:t>
            </a:r>
            <a:r>
              <a:rPr lang="en-AU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s read coverage captured from Chinese Spring as control, second row shows reads from Spica, followed by 4 recombinant lines: </a:t>
            </a:r>
            <a:r>
              <a:rPr lang="en-AU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2</a:t>
            </a:r>
            <a:r>
              <a:rPr lang="en-AU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AU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6</a:t>
            </a:r>
            <a:r>
              <a:rPr lang="en-AU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AU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8</a:t>
            </a:r>
            <a:r>
              <a:rPr lang="en-AU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AU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4</a:t>
            </a:r>
            <a:r>
              <a:rPr lang="en-AU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The bottom row shows reads from the </a:t>
            </a:r>
            <a:r>
              <a:rPr lang="en-AU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MA</a:t>
            </a:r>
            <a:r>
              <a:rPr lang="en-AU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res parent Maringa. The phenotype of the recombinant lines correlates with their genotype: black type </a:t>
            </a:r>
            <a:r>
              <a:rPr lang="en-AU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MA</a:t>
            </a:r>
            <a:r>
              <a:rPr lang="en-AU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res, orange </a:t>
            </a:r>
            <a:r>
              <a:rPr lang="en-AU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MA</a:t>
            </a:r>
            <a:r>
              <a:rPr lang="en-AU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sus. No recombination breakpoints were detected within the 23 kb interval</a:t>
            </a:r>
            <a:r>
              <a:rPr lang="en-AU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The approximate location of the </a:t>
            </a:r>
            <a:r>
              <a:rPr lang="en-AU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MA</a:t>
            </a:r>
            <a:r>
              <a:rPr lang="en-AU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AU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 is shown</a:t>
            </a:r>
            <a:r>
              <a:rPr lang="en-AU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AU" sz="12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0800000">
            <a:off x="4702854" y="4635164"/>
            <a:ext cx="2990233" cy="107156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7839372" y="4537882"/>
            <a:ext cx="9509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LMA</a:t>
            </a:r>
            <a:r>
              <a:rPr lang="en-US" sz="1200" i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gene</a:t>
            </a:r>
            <a:endParaRPr lang="en-AU" sz="12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7238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6</Words>
  <Application>Microsoft Office PowerPoint</Application>
  <PresentationFormat>Widescreen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he University of Adelaid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yl Mares</dc:creator>
  <cp:lastModifiedBy>Daryl Mares</cp:lastModifiedBy>
  <cp:revision>1</cp:revision>
  <dcterms:created xsi:type="dcterms:W3CDTF">2021-01-28T22:04:29Z</dcterms:created>
  <dcterms:modified xsi:type="dcterms:W3CDTF">2021-01-28T22:05:04Z</dcterms:modified>
</cp:coreProperties>
</file>